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3.xml" ContentType="application/vnd.ms-office.chartcolor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84" r:id="rId2"/>
  </p:sldIdLst>
  <p:sldSz cx="50406300" cy="36004500"/>
  <p:notesSz cx="6858000" cy="9144000"/>
  <p:defaultTextStyle>
    <a:defPPr marL="0" marR="0" indent="0" algn="l" defTabSz="2301179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45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1pPr>
    <a:lvl2pPr marL="0" marR="0" indent="862942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2pPr>
    <a:lvl3pPr marL="0" marR="0" indent="1725884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3pPr>
    <a:lvl4pPr marL="0" marR="0" indent="258882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4pPr>
    <a:lvl5pPr marL="0" marR="0" indent="3451769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5pPr>
    <a:lvl6pPr marL="0" marR="0" indent="5752948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6pPr>
    <a:lvl7pPr marL="0" marR="0" indent="690353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7pPr>
    <a:lvl8pPr marL="0" marR="0" indent="805412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8pPr>
    <a:lvl9pPr marL="0" marR="0" indent="920471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340">
          <p15:clr>
            <a:srgbClr val="A4A3A4"/>
          </p15:clr>
        </p15:guide>
        <p15:guide id="2" pos="158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CC00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2E8"/>
          </a:solidFill>
        </a:fill>
      </a:tcStyle>
    </a:wholeTbl>
    <a:band2H>
      <a:tcTxStyle/>
      <a:tcStyle>
        <a:tcBdr/>
        <a:fill>
          <a:solidFill>
            <a:srgbClr val="E6EAF4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6CB"/>
          </a:solidFill>
        </a:fill>
      </a:tcStyle>
    </a:wholeTbl>
    <a:band2H>
      <a:tcTxStyle/>
      <a:tcStyle>
        <a:tcBdr/>
        <a:fill>
          <a:solidFill>
            <a:srgbClr val="E6ECE7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8D230F3-CF80-4859-8CE7-A43EE81993B5}" styleName="Estilo claro 1 - Acento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Estilo claro 1 - Acento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27102A9-8310-4765-A935-A1911B00CA55}" styleName="Estilo claro 1 - Acento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Estilo claro 1 - Acento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17292A2E-F333-43FB-9621-5CBBE7FDCDCB}" styleName="Estilo claro 2 - Acento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A111915-BE36-4E01-A7E5-04B1672EAD32}" styleName="Estilo claro 2 - Acento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>
      <p:cViewPr>
        <p:scale>
          <a:sx n="15" d="100"/>
          <a:sy n="15" d="100"/>
        </p:scale>
        <p:origin x="-1008" y="0"/>
      </p:cViewPr>
      <p:guideLst>
        <p:guide orient="horz" pos="11340"/>
        <p:guide pos="158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193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Relationship Id="rId4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713097809676441E-2"/>
          <c:y val="5.5155478003714439E-2"/>
          <c:w val="0.74169902211756977"/>
          <c:h val="0.5305724655595003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fHbp por CC-edad'!$I$115</c:f>
              <c:strCache>
                <c:ptCount val="1"/>
                <c:pt idx="0">
                  <c:v>fHbp variant family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Hbp por CC-edad'!$H$116:$H$129</c:f>
              <c:strCache>
                <c:ptCount val="14"/>
                <c:pt idx="0">
                  <c:v>ST-198 complex</c:v>
                </c:pt>
                <c:pt idx="1">
                  <c:v>ST-41/44 complex</c:v>
                </c:pt>
                <c:pt idx="2">
                  <c:v>ST-175 complex</c:v>
                </c:pt>
                <c:pt idx="3">
                  <c:v>ST-53 complex
</c:v>
                </c:pt>
                <c:pt idx="4">
                  <c:v>ST-32 complex</c:v>
                </c:pt>
                <c:pt idx="5">
                  <c:v>ST-11 complex</c:v>
                </c:pt>
                <c:pt idx="6">
                  <c:v>ST-865 complex</c:v>
                </c:pt>
                <c:pt idx="7">
                  <c:v>ST-1136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35 complex</c:v>
                </c:pt>
                <c:pt idx="11">
                  <c:v>ST-60 complex</c:v>
                </c:pt>
                <c:pt idx="12">
                  <c:v>ST-461 complex</c:v>
                </c:pt>
                <c:pt idx="13">
                  <c:v>Singleton</c:v>
                </c:pt>
              </c:strCache>
            </c:strRef>
          </c:cat>
          <c:val>
            <c:numRef>
              <c:f>'fHbp por CC-edad'!$I$116:$I$129</c:f>
              <c:numCache>
                <c:formatCode>General</c:formatCode>
                <c:ptCount val="14"/>
                <c:pt idx="0">
                  <c:v>23</c:v>
                </c:pt>
                <c:pt idx="1">
                  <c:v>0</c:v>
                </c:pt>
                <c:pt idx="2">
                  <c:v>1</c:v>
                </c:pt>
                <c:pt idx="3" formatCode="@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1</c:v>
                </c:pt>
              </c:numCache>
            </c:numRef>
          </c:val>
        </c:ser>
        <c:ser>
          <c:idx val="1"/>
          <c:order val="1"/>
          <c:tx>
            <c:strRef>
              <c:f>'fHbp por CC-edad'!$J$115</c:f>
              <c:strCache>
                <c:ptCount val="1"/>
                <c:pt idx="0">
                  <c:v>fHbp variant family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fHbp por CC-edad'!$H$116:$H$129</c:f>
              <c:strCache>
                <c:ptCount val="14"/>
                <c:pt idx="0">
                  <c:v>ST-198 complex</c:v>
                </c:pt>
                <c:pt idx="1">
                  <c:v>ST-41/44 complex</c:v>
                </c:pt>
                <c:pt idx="2">
                  <c:v>ST-175 complex</c:v>
                </c:pt>
                <c:pt idx="3">
                  <c:v>ST-53 complex
</c:v>
                </c:pt>
                <c:pt idx="4">
                  <c:v>ST-32 complex</c:v>
                </c:pt>
                <c:pt idx="5">
                  <c:v>ST-11 complex</c:v>
                </c:pt>
                <c:pt idx="6">
                  <c:v>ST-865 complex</c:v>
                </c:pt>
                <c:pt idx="7">
                  <c:v>ST-1136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35 complex</c:v>
                </c:pt>
                <c:pt idx="11">
                  <c:v>ST-60 complex</c:v>
                </c:pt>
                <c:pt idx="12">
                  <c:v>ST-461 complex</c:v>
                </c:pt>
                <c:pt idx="13">
                  <c:v>Singleton</c:v>
                </c:pt>
              </c:strCache>
            </c:strRef>
          </c:cat>
          <c:val>
            <c:numRef>
              <c:f>'fHbp por CC-edad'!$J$116:$J$129</c:f>
              <c:numCache>
                <c:formatCode>General</c:formatCode>
                <c:ptCount val="14"/>
                <c:pt idx="0">
                  <c:v>0</c:v>
                </c:pt>
                <c:pt idx="1">
                  <c:v>6</c:v>
                </c:pt>
                <c:pt idx="2">
                  <c:v>2</c:v>
                </c:pt>
                <c:pt idx="3">
                  <c:v>3</c:v>
                </c:pt>
                <c:pt idx="4">
                  <c:v>2</c:v>
                </c:pt>
                <c:pt idx="5">
                  <c:v>2</c:v>
                </c:pt>
                <c:pt idx="6">
                  <c:v>1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8</c:v>
                </c:pt>
                <c:pt idx="11">
                  <c:v>0</c:v>
                </c:pt>
                <c:pt idx="12">
                  <c:v>0</c:v>
                </c:pt>
                <c:pt idx="13">
                  <c:v>7</c:v>
                </c:pt>
              </c:numCache>
            </c:numRef>
          </c:val>
        </c:ser>
        <c:ser>
          <c:idx val="2"/>
          <c:order val="2"/>
          <c:tx>
            <c:strRef>
              <c:f>'fHbp por CC-edad'!$K$115</c:f>
              <c:strCache>
                <c:ptCount val="1"/>
                <c:pt idx="0">
                  <c:v>fHbp variant family 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fHbp por CC-edad'!$H$116:$H$129</c:f>
              <c:strCache>
                <c:ptCount val="14"/>
                <c:pt idx="0">
                  <c:v>ST-198 complex</c:v>
                </c:pt>
                <c:pt idx="1">
                  <c:v>ST-41/44 complex</c:v>
                </c:pt>
                <c:pt idx="2">
                  <c:v>ST-175 complex</c:v>
                </c:pt>
                <c:pt idx="3">
                  <c:v>ST-53 complex
</c:v>
                </c:pt>
                <c:pt idx="4">
                  <c:v>ST-32 complex</c:v>
                </c:pt>
                <c:pt idx="5">
                  <c:v>ST-11 complex</c:v>
                </c:pt>
                <c:pt idx="6">
                  <c:v>ST-865 complex</c:v>
                </c:pt>
                <c:pt idx="7">
                  <c:v>ST-1136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35 complex</c:v>
                </c:pt>
                <c:pt idx="11">
                  <c:v>ST-60 complex</c:v>
                </c:pt>
                <c:pt idx="12">
                  <c:v>ST-461 complex</c:v>
                </c:pt>
                <c:pt idx="13">
                  <c:v>Singleton</c:v>
                </c:pt>
              </c:strCache>
            </c:strRef>
          </c:cat>
          <c:val>
            <c:numRef>
              <c:f>'fHbp por CC-edad'!$K$116:$K$129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1</c:v>
                </c:pt>
                <c:pt idx="13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9888384"/>
        <c:axId val="39940096"/>
      </c:barChart>
      <c:catAx>
        <c:axId val="39888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39940096"/>
        <c:crosses val="autoZero"/>
        <c:auto val="1"/>
        <c:lblAlgn val="ctr"/>
        <c:lblOffset val="100"/>
        <c:noMultiLvlLbl val="0"/>
      </c:catAx>
      <c:valAx>
        <c:axId val="39940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398883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86527644964812267"/>
          <c:y val="5.1341214713783195E-2"/>
          <c:w val="0.12773350446811224"/>
          <c:h val="0.541088509769612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600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3704</cdr:x>
      <cdr:y>0.02662</cdr:y>
    </cdr:from>
    <cdr:to>
      <cdr:x>0.13688</cdr:x>
      <cdr:y>0.11227</cdr:y>
    </cdr:to>
    <cdr:sp macro="" textlink="">
      <cdr:nvSpPr>
        <cdr:cNvPr id="2" name="CuadroTexto 1"/>
        <cdr:cNvSpPr txBox="1"/>
      </cdr:nvSpPr>
      <cdr:spPr>
        <a:xfrm xmlns:a="http://schemas.openxmlformats.org/drawingml/2006/main">
          <a:off x="219076" y="73025"/>
          <a:ext cx="590550" cy="2349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s-AR" sz="1100"/>
            <a:t>n</a:t>
          </a:r>
        </a:p>
      </cdr:txBody>
    </cdr:sp>
  </cdr:relSizeAnchor>
  <cdr:relSizeAnchor xmlns:cdr="http://schemas.openxmlformats.org/drawingml/2006/chartDrawing">
    <cdr:from>
      <cdr:x>0.36549</cdr:x>
      <cdr:y>0.89918</cdr:y>
    </cdr:from>
    <cdr:to>
      <cdr:x>0.59172</cdr:x>
      <cdr:y>0.9552</cdr:y>
    </cdr:to>
    <cdr:sp macro="" textlink="">
      <cdr:nvSpPr>
        <cdr:cNvPr id="3" name="2 CuadroTexto"/>
        <cdr:cNvSpPr txBox="1"/>
      </cdr:nvSpPr>
      <cdr:spPr>
        <a:xfrm xmlns:a="http://schemas.openxmlformats.org/drawingml/2006/main">
          <a:off x="16228284" y="19266718"/>
          <a:ext cx="10045116" cy="120032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2700" cap="flat">
          <a:noFill/>
          <a:miter lim="400000"/>
        </a:ln>
        <a:effectLst xmlns:a="http://schemas.openxmlformats.org/drawingml/2006/main"/>
        <a:sp3d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none"/>
      </cdr:style>
      <cdr:txBody>
        <a:bodyPr xmlns:a="http://schemas.openxmlformats.org/drawingml/2006/main" rot="0" spcFirstLastPara="1" vertOverflow="clip" horzOverflow="overflow" vert="horz" wrap="square" lIns="45719" tIns="45719" rIns="45719" bIns="45719" numCol="1" spcCol="38100" rtlCol="0" anchor="t">
          <a:spAutoFit/>
        </a:bodyPr>
        <a:lstStyle xmlns:a="http://schemas.openxmlformats.org/drawingml/2006/main"/>
        <a:p xmlns:a="http://schemas.openxmlformats.org/drawingml/2006/main">
          <a:pPr marL="0" marR="0" indent="0" algn="ctr" defTabSz="1168400" rtl="0" fontAlgn="auto" latinLnBrk="0" hangingPunct="0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</a:pPr>
          <a:r>
            <a:rPr kumimoji="0" lang="es-AR" sz="7200" b="0" i="0" u="none" strike="noStrike" cap="none" spc="0" normalizeH="0" baseline="0" dirty="0" err="1" smtClean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rPr>
            <a:t>Clonal</a:t>
          </a:r>
          <a:r>
            <a:rPr kumimoji="0" lang="es-AR" sz="7200" b="0" i="0" u="none" strike="noStrike" cap="none" spc="0" normalizeH="0" baseline="0" dirty="0" smtClean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rPr>
            <a:t> </a:t>
          </a:r>
          <a:r>
            <a:rPr kumimoji="0" lang="es-AR" sz="7200" b="0" i="0" u="none" strike="noStrike" cap="none" spc="0" normalizeH="0" baseline="0" dirty="0" err="1" smtClean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rPr>
            <a:t>complex</a:t>
          </a:r>
          <a:endParaRPr kumimoji="0" lang="es-AR" sz="7200" b="0" i="0" u="none" strike="noStrike" cap="none" spc="0" normalizeH="0" baseline="0" dirty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Shape 208"/>
          <p:cNvSpPr>
            <a:spLocks noGrp="1" noRot="1" noChangeAspect="1"/>
          </p:cNvSpPr>
          <p:nvPr>
            <p:ph type="sldImg"/>
          </p:nvPr>
        </p:nvSpPr>
        <p:spPr>
          <a:xfrm>
            <a:off x="1028700" y="685800"/>
            <a:ext cx="48006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09" name="Shape 20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387140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2940395" latinLnBrk="0">
      <a:defRPr sz="3500">
        <a:latin typeface="+mn-lt"/>
        <a:ea typeface="+mn-ea"/>
        <a:cs typeface="+mn-cs"/>
        <a:sym typeface="Arial"/>
      </a:defRPr>
    </a:lvl1pPr>
    <a:lvl2pPr indent="575295" defTabSz="2940395" latinLnBrk="0">
      <a:defRPr sz="3500">
        <a:latin typeface="+mn-lt"/>
        <a:ea typeface="+mn-ea"/>
        <a:cs typeface="+mn-cs"/>
        <a:sym typeface="Arial"/>
      </a:defRPr>
    </a:lvl2pPr>
    <a:lvl3pPr indent="1150590" defTabSz="2940395" latinLnBrk="0">
      <a:defRPr sz="3500">
        <a:latin typeface="+mn-lt"/>
        <a:ea typeface="+mn-ea"/>
        <a:cs typeface="+mn-cs"/>
        <a:sym typeface="Arial"/>
      </a:defRPr>
    </a:lvl3pPr>
    <a:lvl4pPr indent="1725884" defTabSz="2940395" latinLnBrk="0">
      <a:defRPr sz="3500">
        <a:latin typeface="+mn-lt"/>
        <a:ea typeface="+mn-ea"/>
        <a:cs typeface="+mn-cs"/>
        <a:sym typeface="Arial"/>
      </a:defRPr>
    </a:lvl4pPr>
    <a:lvl5pPr indent="2301179" defTabSz="2940395" latinLnBrk="0">
      <a:defRPr sz="3500">
        <a:latin typeface="+mn-lt"/>
        <a:ea typeface="+mn-ea"/>
        <a:cs typeface="+mn-cs"/>
        <a:sym typeface="Arial"/>
      </a:defRPr>
    </a:lvl5pPr>
    <a:lvl6pPr indent="2876474" defTabSz="2940395" latinLnBrk="0">
      <a:defRPr sz="3500">
        <a:latin typeface="+mn-lt"/>
        <a:ea typeface="+mn-ea"/>
        <a:cs typeface="+mn-cs"/>
        <a:sym typeface="Arial"/>
      </a:defRPr>
    </a:lvl6pPr>
    <a:lvl7pPr indent="3451769" defTabSz="2940395" latinLnBrk="0">
      <a:defRPr sz="3500">
        <a:latin typeface="+mn-lt"/>
        <a:ea typeface="+mn-ea"/>
        <a:cs typeface="+mn-cs"/>
        <a:sym typeface="Arial"/>
      </a:defRPr>
    </a:lvl7pPr>
    <a:lvl8pPr indent="4027063" defTabSz="2940395" latinLnBrk="0">
      <a:defRPr sz="3500">
        <a:latin typeface="+mn-lt"/>
        <a:ea typeface="+mn-ea"/>
        <a:cs typeface="+mn-cs"/>
        <a:sym typeface="Arial"/>
      </a:defRPr>
    </a:lvl8pPr>
    <a:lvl9pPr indent="4602358" defTabSz="2940395" latinLnBrk="0">
      <a:defRPr sz="35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0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129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38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4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8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1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5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72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73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1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82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18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92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1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0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itle Text"/>
          <p:cNvSpPr txBox="1">
            <a:spLocks noGrp="1"/>
          </p:cNvSpPr>
          <p:nvPr>
            <p:ph type="title"/>
          </p:nvPr>
        </p:nvSpPr>
        <p:spPr>
          <a:xfrm>
            <a:off x="3782114" y="11184731"/>
            <a:ext cx="42842073" cy="7717631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1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560126" y="20402552"/>
            <a:ext cx="35286054" cy="9201150"/>
          </a:xfrm>
          <a:prstGeom prst="rect">
            <a:avLst/>
          </a:prstGeom>
        </p:spPr>
        <p:txBody>
          <a:bodyPr/>
          <a:lstStyle>
            <a:lvl1pPr marL="0" indent="0" algn="ctr"/>
            <a:lvl2pPr marL="0" indent="1150590" algn="ctr"/>
            <a:lvl3pPr marL="0" indent="2301179" algn="ctr"/>
            <a:lvl4pPr marL="0" indent="3451769" algn="ctr"/>
            <a:lvl5pPr marL="0" indent="4602358" algn="ctr"/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Off val="4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2518674" y="1441848"/>
            <a:ext cx="45368952" cy="60007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4" y="8401053"/>
            <a:ext cx="45368952" cy="237613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5217295" y="33023825"/>
            <a:ext cx="907223" cy="694030"/>
          </a:xfrm>
          <a:prstGeom prst="rect">
            <a:avLst/>
          </a:prstGeom>
          <a:ln w="12700">
            <a:miter lim="400000"/>
          </a:ln>
        </p:spPr>
        <p:txBody>
          <a:bodyPr wrap="none" lIns="115056" tIns="115059" rIns="115056" bIns="115059" anchor="ctr">
            <a:spAutoFit/>
          </a:bodyPr>
          <a:lstStyle>
            <a:lvl1pPr algn="r">
              <a:defRPr sz="30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6" r:id="rId5"/>
    <p:sldLayoutId id="2147483657" r:id="rId6"/>
    <p:sldLayoutId id="2147483658" r:id="rId7"/>
    <p:sldLayoutId id="2147483659" r:id="rId8"/>
    <p:sldLayoutId id="2147483660" r:id="rId9"/>
    <p:sldLayoutId id="2147483661" r:id="rId10"/>
    <p:sldLayoutId id="2147483662" r:id="rId11"/>
    <p:sldLayoutId id="2147483663" r:id="rId12"/>
    <p:sldLayoutId id="2147483664" r:id="rId13"/>
    <p:sldLayoutId id="2147483665" r:id="rId14"/>
    <p:sldLayoutId id="2147483666" r:id="rId15"/>
    <p:sldLayoutId id="2147483667" r:id="rId16"/>
    <p:sldLayoutId id="2147483668" r:id="rId17"/>
    <p:sldLayoutId id="2147483669" r:id="rId18"/>
    <p:sldLayoutId id="2147483670" r:id="rId19"/>
  </p:sldLayoutIdLst>
  <p:transition spd="med"/>
  <p:txStyles>
    <p:titleStyle>
      <a:lvl1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115059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30117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45176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4602358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titleStyle>
    <p:bodyStyle>
      <a:lvl1pPr marL="862942" marR="0" indent="-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862942" marR="0" indent="-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862942" marR="0" indent="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862942" marR="0" indent="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862942" marR="0" indent="143823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862942" marR="0" indent="258882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862942" marR="0" indent="373941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862942" marR="0" indent="489000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862942" marR="0" indent="604059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bodyStyle>
    <p:otherStyle>
      <a:lvl1pPr marL="0" marR="0" indent="0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862942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1725884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258882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3451769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5752948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690353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805412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920471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1512518" y="2160490"/>
            <a:ext cx="48029336" cy="36317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00" b="1" dirty="0" smtClean="0">
                <a:cs typeface="Calibri" panose="020F0502020204030204" pitchFamily="34" charset="0"/>
              </a:rPr>
              <a:t>S8 Figure: Distribution of </a:t>
            </a:r>
            <a:r>
              <a:rPr lang="en-GB" sz="11500" b="1" dirty="0" err="1" smtClean="0">
                <a:cs typeface="Calibri" panose="020F0502020204030204" pitchFamily="34" charset="0"/>
              </a:rPr>
              <a:t>fHbp</a:t>
            </a:r>
            <a:r>
              <a:rPr lang="en-GB" sz="11500" b="1" dirty="0" smtClean="0">
                <a:cs typeface="Calibri" panose="020F0502020204030204" pitchFamily="34" charset="0"/>
              </a:rPr>
              <a:t> variant families by clonal </a:t>
            </a:r>
            <a:r>
              <a:rPr lang="en-GB" sz="11500" b="1" dirty="0">
                <a:cs typeface="Calibri" panose="020F0502020204030204" pitchFamily="34" charset="0"/>
              </a:rPr>
              <a:t>complex in the </a:t>
            </a:r>
            <a:r>
              <a:rPr lang="en-GB" sz="11500" b="1" dirty="0" smtClean="0">
                <a:cs typeface="Calibri" panose="020F0502020204030204" pitchFamily="34" charset="0"/>
              </a:rPr>
              <a:t>10-17 </a:t>
            </a:r>
            <a:r>
              <a:rPr lang="en-GB" sz="11500" b="1" dirty="0">
                <a:cs typeface="Calibri" panose="020F0502020204030204" pitchFamily="34" charset="0"/>
              </a:rPr>
              <a:t>year old group</a:t>
            </a:r>
            <a:endParaRPr lang="es-AR" sz="11500" dirty="0">
              <a:cs typeface="Calibri" panose="020F0502020204030204" pitchFamily="34" charset="0"/>
            </a:endParaRPr>
          </a:p>
        </p:txBody>
      </p:sp>
      <p:sp>
        <p:nvSpPr>
          <p:cNvPr id="3" name="CuadroTexto 2"/>
          <p:cNvSpPr txBox="1"/>
          <p:nvPr/>
        </p:nvSpPr>
        <p:spPr>
          <a:xfrm>
            <a:off x="6337054" y="11017474"/>
            <a:ext cx="1211686" cy="110799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ctr" defTabSz="1168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AR" sz="66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Arial"/>
              </a:rPr>
              <a:t>n</a:t>
            </a:r>
            <a:endParaRPr kumimoji="0" lang="es-AR" sz="66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endParaRPr>
          </a:p>
        </p:txBody>
      </p:sp>
      <p:sp>
        <p:nvSpPr>
          <p:cNvPr id="5" name="CuadroTexto 4"/>
          <p:cNvSpPr txBox="1"/>
          <p:nvPr/>
        </p:nvSpPr>
        <p:spPr>
          <a:xfrm>
            <a:off x="43277158" y="30315618"/>
            <a:ext cx="1817162" cy="110799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ctr" defTabSz="1168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AR" sz="66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panose="020F0502020204030204" pitchFamily="34" charset="0"/>
                <a:cs typeface="Calibri" panose="020F0502020204030204" pitchFamily="34" charset="0"/>
                <a:sym typeface="Arial"/>
              </a:rPr>
              <a:t>n=65</a:t>
            </a:r>
            <a:endParaRPr kumimoji="0" lang="es-AR" sz="6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panose="020F0502020204030204" pitchFamily="34" charset="0"/>
              <a:cs typeface="Calibri" panose="020F0502020204030204" pitchFamily="34" charset="0"/>
              <a:sym typeface="Arial"/>
            </a:endParaRPr>
          </a:p>
        </p:txBody>
      </p:sp>
      <p:graphicFrame>
        <p:nvGraphicFramePr>
          <p:cNvPr id="7" name="Gráfico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3863833"/>
              </p:ext>
            </p:extLst>
          </p:nvPr>
        </p:nvGraphicFramePr>
        <p:xfrm>
          <a:off x="4276344" y="12156894"/>
          <a:ext cx="44401413" cy="214269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835557866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8F8F8F"/>
      </a:accent3>
      <a:accent4>
        <a:srgbClr val="707070"/>
      </a:accent4>
      <a:accent5>
        <a:srgbClr val="AAB8DC"/>
      </a:accent5>
      <a:accent6>
        <a:srgbClr val="007B26"/>
      </a:accent6>
      <a:hlink>
        <a:srgbClr val="0000FF"/>
      </a:hlink>
      <a:folHlink>
        <a:srgbClr val="FF00FF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0</TotalTime>
  <Words>22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a</dc:creator>
  <cp:lastModifiedBy>Meenakshi Akasapu</cp:lastModifiedBy>
  <cp:revision>223</cp:revision>
  <dcterms:modified xsi:type="dcterms:W3CDTF">2021-03-04T00:28:33Z</dcterms:modified>
</cp:coreProperties>
</file>